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59FB6BA-7B90-4B20-8719-A7DF7C02B4B7}" v="6" dt="2025-06-02T19:58:47.03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17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7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ylor Wang" userId="a6f4690f40ca3885" providerId="LiveId" clId="{4923778D-753A-48E0-BC78-FE727F099CBC}"/>
    <pc:docChg chg="modSld">
      <pc:chgData name="Taylor Wang" userId="a6f4690f40ca3885" providerId="LiveId" clId="{4923778D-753A-48E0-BC78-FE727F099CBC}" dt="2025-05-01T17:43:45.290" v="10"/>
      <pc:docMkLst>
        <pc:docMk/>
      </pc:docMkLst>
      <pc:sldChg chg="addSp delSp modSp mod">
        <pc:chgData name="Taylor Wang" userId="a6f4690f40ca3885" providerId="LiveId" clId="{4923778D-753A-48E0-BC78-FE727F099CBC}" dt="2025-05-01T17:19:26.208" v="5" actId="1076"/>
        <pc:sldMkLst>
          <pc:docMk/>
          <pc:sldMk cId="2420644626" sldId="256"/>
        </pc:sldMkLst>
        <pc:picChg chg="add mod">
          <ac:chgData name="Taylor Wang" userId="a6f4690f40ca3885" providerId="LiveId" clId="{4923778D-753A-48E0-BC78-FE727F099CBC}" dt="2025-05-01T17:09:23.124" v="1" actId="1076"/>
          <ac:picMkLst>
            <pc:docMk/>
            <pc:sldMk cId="2420644626" sldId="256"/>
            <ac:picMk id="4" creationId="{011AC18B-5951-9118-8351-2319715D0E88}"/>
          </ac:picMkLst>
        </pc:picChg>
        <pc:picChg chg="add mod">
          <ac:chgData name="Taylor Wang" userId="a6f4690f40ca3885" providerId="LiveId" clId="{4923778D-753A-48E0-BC78-FE727F099CBC}" dt="2025-05-01T17:19:26.208" v="5" actId="1076"/>
          <ac:picMkLst>
            <pc:docMk/>
            <pc:sldMk cId="2420644626" sldId="256"/>
            <ac:picMk id="6" creationId="{E3F154BD-3C9B-81DC-FA6C-B8626A56B2E8}"/>
          </ac:picMkLst>
        </pc:picChg>
      </pc:sldChg>
      <pc:sldChg chg="addSp modSp mod">
        <pc:chgData name="Taylor Wang" userId="a6f4690f40ca3885" providerId="LiveId" clId="{4923778D-753A-48E0-BC78-FE727F099CBC}" dt="2025-05-01T17:35:22.507" v="9" actId="1076"/>
        <pc:sldMkLst>
          <pc:docMk/>
          <pc:sldMk cId="2317304052" sldId="257"/>
        </pc:sldMkLst>
        <pc:picChg chg="add mod">
          <ac:chgData name="Taylor Wang" userId="a6f4690f40ca3885" providerId="LiveId" clId="{4923778D-753A-48E0-BC78-FE727F099CBC}" dt="2025-05-01T17:27:56.711" v="7" actId="1076"/>
          <ac:picMkLst>
            <pc:docMk/>
            <pc:sldMk cId="2317304052" sldId="257"/>
            <ac:picMk id="2" creationId="{98B4F4E2-1033-BE4C-FFE9-CBCB27BFD157}"/>
          </ac:picMkLst>
        </pc:picChg>
        <pc:picChg chg="add mod">
          <ac:chgData name="Taylor Wang" userId="a6f4690f40ca3885" providerId="LiveId" clId="{4923778D-753A-48E0-BC78-FE727F099CBC}" dt="2025-05-01T17:35:22.507" v="9" actId="1076"/>
          <ac:picMkLst>
            <pc:docMk/>
            <pc:sldMk cId="2317304052" sldId="257"/>
            <ac:picMk id="3" creationId="{9D2E79EC-C0DA-6A70-4BC6-9B7EFCCAB9E2}"/>
          </ac:picMkLst>
        </pc:picChg>
      </pc:sldChg>
      <pc:sldChg chg="addSp">
        <pc:chgData name="Taylor Wang" userId="a6f4690f40ca3885" providerId="LiveId" clId="{4923778D-753A-48E0-BC78-FE727F099CBC}" dt="2025-05-01T17:43:45.290" v="10"/>
        <pc:sldMkLst>
          <pc:docMk/>
          <pc:sldMk cId="1078854530" sldId="258"/>
        </pc:sldMkLst>
      </pc:sldChg>
    </pc:docChg>
  </pc:docChgLst>
  <pc:docChgLst>
    <pc:chgData name="Taylor Wang" userId="a6f4690f40ca3885" providerId="LiveId" clId="{E59FB6BA-7B90-4B20-8719-A7DF7C02B4B7}"/>
    <pc:docChg chg="custSel delSld modSld">
      <pc:chgData name="Taylor Wang" userId="a6f4690f40ca3885" providerId="LiveId" clId="{E59FB6BA-7B90-4B20-8719-A7DF7C02B4B7}" dt="2025-06-02T19:58:52.276" v="61" actId="1076"/>
      <pc:docMkLst>
        <pc:docMk/>
      </pc:docMkLst>
      <pc:sldChg chg="addSp modSp">
        <pc:chgData name="Taylor Wang" userId="a6f4690f40ca3885" providerId="LiveId" clId="{E59FB6BA-7B90-4B20-8719-A7DF7C02B4B7}" dt="2025-06-02T19:58:47.038" v="60"/>
        <pc:sldMkLst>
          <pc:docMk/>
          <pc:sldMk cId="2420644626" sldId="256"/>
        </pc:sldMkLst>
        <pc:spChg chg="add mod">
          <ac:chgData name="Taylor Wang" userId="a6f4690f40ca3885" providerId="LiveId" clId="{E59FB6BA-7B90-4B20-8719-A7DF7C02B4B7}" dt="2025-06-02T19:58:47.038" v="60"/>
          <ac:spMkLst>
            <pc:docMk/>
            <pc:sldMk cId="2420644626" sldId="256"/>
            <ac:spMk id="2" creationId="{FAB0D20B-4B90-8553-413C-7D7E9ED3F6EE}"/>
          </ac:spMkLst>
        </pc:spChg>
      </pc:sldChg>
      <pc:sldChg chg="addSp modSp mod">
        <pc:chgData name="Taylor Wang" userId="a6f4690f40ca3885" providerId="LiveId" clId="{E59FB6BA-7B90-4B20-8719-A7DF7C02B4B7}" dt="2025-06-02T19:58:43.647" v="59" actId="1076"/>
        <pc:sldMkLst>
          <pc:docMk/>
          <pc:sldMk cId="2317304052" sldId="257"/>
        </pc:sldMkLst>
        <pc:spChg chg="add mod">
          <ac:chgData name="Taylor Wang" userId="a6f4690f40ca3885" providerId="LiveId" clId="{E59FB6BA-7B90-4B20-8719-A7DF7C02B4B7}" dt="2025-06-02T19:58:43.647" v="59" actId="1076"/>
          <ac:spMkLst>
            <pc:docMk/>
            <pc:sldMk cId="2317304052" sldId="257"/>
            <ac:spMk id="4" creationId="{719D8F93-32FF-6679-D786-15888DB1F7A4}"/>
          </ac:spMkLst>
        </pc:spChg>
      </pc:sldChg>
      <pc:sldChg chg="addSp delSp modSp mod">
        <pc:chgData name="Taylor Wang" userId="a6f4690f40ca3885" providerId="LiveId" clId="{E59FB6BA-7B90-4B20-8719-A7DF7C02B4B7}" dt="2025-06-02T19:58:52.276" v="61" actId="1076"/>
        <pc:sldMkLst>
          <pc:docMk/>
          <pc:sldMk cId="1078854530" sldId="258"/>
        </pc:sldMkLst>
        <pc:spChg chg="add">
          <ac:chgData name="Taylor Wang" userId="a6f4690f40ca3885" providerId="LiveId" clId="{E59FB6BA-7B90-4B20-8719-A7DF7C02B4B7}" dt="2025-06-02T19:57:16.257" v="0"/>
          <ac:spMkLst>
            <pc:docMk/>
            <pc:sldMk cId="1078854530" sldId="258"/>
            <ac:spMk id="3" creationId="{FC948AFA-667E-70B2-D7BA-4E5838B59927}"/>
          </ac:spMkLst>
        </pc:spChg>
        <pc:spChg chg="add mod">
          <ac:chgData name="Taylor Wang" userId="a6f4690f40ca3885" providerId="LiveId" clId="{E59FB6BA-7B90-4B20-8719-A7DF7C02B4B7}" dt="2025-06-02T19:58:28.716" v="53" actId="1076"/>
          <ac:spMkLst>
            <pc:docMk/>
            <pc:sldMk cId="1078854530" sldId="258"/>
            <ac:spMk id="6" creationId="{6649CDB1-BCE8-1A66-E220-2E5F194C2ADF}"/>
          </ac:spMkLst>
        </pc:spChg>
        <pc:picChg chg="del">
          <ac:chgData name="Taylor Wang" userId="a6f4690f40ca3885" providerId="LiveId" clId="{E59FB6BA-7B90-4B20-8719-A7DF7C02B4B7}" dt="2025-06-02T19:57:24.283" v="3" actId="478"/>
          <ac:picMkLst>
            <pc:docMk/>
            <pc:sldMk cId="1078854530" sldId="258"/>
            <ac:picMk id="2" creationId="{56E41C39-AD91-7E60-4709-44E9BA4ABD33}"/>
          </ac:picMkLst>
        </pc:picChg>
        <pc:picChg chg="add mod modCrop">
          <ac:chgData name="Taylor Wang" userId="a6f4690f40ca3885" providerId="LiveId" clId="{E59FB6BA-7B90-4B20-8719-A7DF7C02B4B7}" dt="2025-06-02T19:58:52.276" v="61" actId="1076"/>
          <ac:picMkLst>
            <pc:docMk/>
            <pc:sldMk cId="1078854530" sldId="258"/>
            <ac:picMk id="4" creationId="{4ABC46D2-23A5-4C3E-3DE4-A54ABF90BDCD}"/>
          </ac:picMkLst>
        </pc:picChg>
        <pc:picChg chg="add mod modCrop">
          <ac:chgData name="Taylor Wang" userId="a6f4690f40ca3885" providerId="LiveId" clId="{E59FB6BA-7B90-4B20-8719-A7DF7C02B4B7}" dt="2025-06-02T19:58:52.276" v="61" actId="1076"/>
          <ac:picMkLst>
            <pc:docMk/>
            <pc:sldMk cId="1078854530" sldId="258"/>
            <ac:picMk id="5" creationId="{8A63E7C2-F76D-C5C5-9D6D-B2E22E126D7D}"/>
          </ac:picMkLst>
        </pc:picChg>
      </pc:sldChg>
      <pc:sldChg chg="del">
        <pc:chgData name="Taylor Wang" userId="a6f4690f40ca3885" providerId="LiveId" clId="{E59FB6BA-7B90-4B20-8719-A7DF7C02B4B7}" dt="2025-06-02T19:58:09.612" v="13" actId="47"/>
        <pc:sldMkLst>
          <pc:docMk/>
          <pc:sldMk cId="1547833225" sldId="2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FBE9D2-DC06-FA2F-F8FA-0417C36DE3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199860-6790-F085-5DA8-C6DA930D96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8D27E9-16C4-466D-3361-86E89F52B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DE7FE3-C68A-BFAD-7B81-64E7F2B3F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71E80-1AE4-A4A4-0155-177263C14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907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53624E-3B3D-2E74-BBDF-53C40F53FD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8AD8C7-1973-A68F-FAB2-CDC60E090D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C46BF0-97C8-7498-46B2-E192CDDBB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C31815-8390-3466-42BC-0C499965B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8E48CA-F58B-DE64-EF4D-0F53703DB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520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FBED9FB-E500-A7A7-839D-EF7B055A8E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026E53-73E0-4170-5AFE-98069994D7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54D3CB-3BC4-04FF-E67B-E83D2CA41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49B42C-8226-1F2F-5181-485B5AB46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5FE3DA-3433-6755-5296-62A9EE331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193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7C7663-4E8D-F5F8-79E3-5BA3CE8ECF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80E02E-859E-2659-DC03-DF41A4BC39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1F9769-6BFE-43AE-7748-061D4C025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751038-83CA-A5C2-683C-1CC4BC619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7109EE-73E5-C9EF-8E72-E85D6366C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574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8F9188-E7B5-59A5-CA17-023B45497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9BD662-D29A-48D3-293E-47E1D5186B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FB0F40-E046-A9A7-EEAA-E7092FC501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867FED-7A95-C7D8-C6E7-0F6981803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A59EA8-781C-6937-4F5B-E3F0D64FD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402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D64285-7E3E-D605-1542-81926433E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7E6B0B-605B-DBCF-0E11-C6B2EFE31B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700050-D903-A98D-11C8-AAA1C424D2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30A7FE-53B2-FD39-AA36-C4A59441A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F4976D-D5C6-684D-E1CC-AC012AFC7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CD1CCE-49F4-3E50-47CA-3ADB2FB79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300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552F4-2397-A076-0010-EE6BF85639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4C50B5-B6FB-9E15-5272-35A775C00C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B2EEFF-80D7-D941-D675-AAEF3D68FD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CBA52D-8DC2-3714-9EFC-D87007C31F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0A86C1-DA9E-5EE2-57C5-63371F6B76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8DE8AE-64F3-C003-69B5-C34B1B6F41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276BBF-27B2-7569-A908-EBE4FFDDC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CF4E42-80FE-04E2-7A1E-2930DFA51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712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31EE4-5219-C429-6005-F46EFB6B37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45E43A-DAFE-C781-3973-B05307549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041973-1117-B7BE-2F94-C7FC2F87A6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5055C2-2FE9-39D5-D4CB-E3257D9CE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132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8BEDF5-6594-AD1A-797D-BC04EAEBF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B41FF29-7EF5-6F0B-EF80-206359D02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FF6375-4947-2ADF-8325-4AC22BFF2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844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E8FBF3-FED1-2B19-7A7D-4EA918F04E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6245B1-CB3C-1507-3273-DEA57BB334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A99CC8-1F32-8916-843E-11DBF0C7ED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744522-A1DB-CC51-BFDC-7FAB1C59A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504E92-5758-8D92-9557-BEFC6B985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E0366A-ED40-47D4-27F1-1D33C316D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143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E24914-104B-374B-14C8-68EB9FBB6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AA5DED7-F064-8AAD-BAB6-AA5EC348AB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FAB056-0059-26E7-62ED-8BF61BC3C5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60FBB6-7332-2AF4-D0D9-B75842BF3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81F7CD-33CA-8584-F57F-2C84FAA9C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34AC89-89FD-DAF6-5E62-79F78049A8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632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B89F28-762B-7618-6E24-C3C3AAA416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C9CC4A-EF4F-9863-19DC-A7D1C8E217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FA71C0-A14E-A9FA-BB04-D99482EC69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3DF37C-6CFB-4903-86D8-27CE97D30D7F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A9A77A-16AB-0C4F-9307-AECC11A253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D8451A-3790-E3F2-F42C-6D34A4B797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B8368D-8435-4D73-87FF-DE28C809F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182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11AC18B-5951-9118-8351-2319715D0E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3472"/>
            <a:ext cx="12192000" cy="336552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3F154BD-3C9B-81DC-FA6C-B8626A56B2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429000"/>
            <a:ext cx="12192000" cy="336552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AB0D20B-4B90-8553-413C-7D7E9ED3F6EE}"/>
              </a:ext>
            </a:extLst>
          </p:cNvPr>
          <p:cNvSpPr txBox="1"/>
          <p:nvPr/>
        </p:nvSpPr>
        <p:spPr>
          <a:xfrm>
            <a:off x="8006962" y="3244334"/>
            <a:ext cx="4118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ll chr# labeled chromosomes are Scer.</a:t>
            </a:r>
          </a:p>
        </p:txBody>
      </p:sp>
    </p:spTree>
    <p:extLst>
      <p:ext uri="{BB962C8B-B14F-4D97-AF65-F5344CB8AC3E}">
        <p14:creationId xmlns:p14="http://schemas.microsoft.com/office/powerpoint/2010/main" val="24206446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78D459A-1489-F8D5-957E-18854424EC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8B4F4E2-1033-BE4C-FFE9-CBCB27BFD1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3472"/>
            <a:ext cx="12192000" cy="336552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D2E79EC-C0DA-6A70-4BC6-9B7EFCCAB9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429000"/>
            <a:ext cx="12192000" cy="336552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19D8F93-32FF-6679-D786-15888DB1F7A4}"/>
              </a:ext>
            </a:extLst>
          </p:cNvPr>
          <p:cNvSpPr txBox="1"/>
          <p:nvPr/>
        </p:nvSpPr>
        <p:spPr>
          <a:xfrm>
            <a:off x="8006962" y="3244334"/>
            <a:ext cx="4118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ll chr# labeled chromosomes are Scer.</a:t>
            </a:r>
          </a:p>
        </p:txBody>
      </p:sp>
    </p:spTree>
    <p:extLst>
      <p:ext uri="{BB962C8B-B14F-4D97-AF65-F5344CB8AC3E}">
        <p14:creationId xmlns:p14="http://schemas.microsoft.com/office/powerpoint/2010/main" val="23173040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9211ED6-DBFE-D12E-A90E-EEF3B452965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AutoShape 2">
            <a:extLst>
              <a:ext uri="{FF2B5EF4-FFF2-40B4-BE49-F238E27FC236}">
                <a16:creationId xmlns:a16="http://schemas.microsoft.com/office/drawing/2014/main" id="{FC948AFA-667E-70B2-D7BA-4E5838B5992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ABC46D2-23A5-4C3E-3DE4-A54ABF90BDC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109" t="48578" r="9739"/>
          <a:stretch/>
        </p:blipFill>
        <p:spPr>
          <a:xfrm>
            <a:off x="55659" y="765601"/>
            <a:ext cx="10869433" cy="216247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A63E7C2-F76D-C5C5-9D6D-B2E22E126D7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90819"/>
          <a:stretch/>
        </p:blipFill>
        <p:spPr>
          <a:xfrm>
            <a:off x="10953409" y="-24944"/>
            <a:ext cx="1119322" cy="420532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649CDB1-BCE8-1A66-E220-2E5F194C2ADF}"/>
              </a:ext>
            </a:extLst>
          </p:cNvPr>
          <p:cNvSpPr txBox="1"/>
          <p:nvPr/>
        </p:nvSpPr>
        <p:spPr>
          <a:xfrm>
            <a:off x="0" y="119270"/>
            <a:ext cx="2735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ll chr# labeled chromosomes are Scer.</a:t>
            </a:r>
          </a:p>
        </p:txBody>
      </p:sp>
    </p:spTree>
    <p:extLst>
      <p:ext uri="{BB962C8B-B14F-4D97-AF65-F5344CB8AC3E}">
        <p14:creationId xmlns:p14="http://schemas.microsoft.com/office/powerpoint/2010/main" val="1078854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9</TotalTime>
  <Words>24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ylor Wang</dc:creator>
  <cp:lastModifiedBy>Taylor Wang</cp:lastModifiedBy>
  <cp:revision>1</cp:revision>
  <dcterms:created xsi:type="dcterms:W3CDTF">2025-05-01T16:43:09Z</dcterms:created>
  <dcterms:modified xsi:type="dcterms:W3CDTF">2025-06-02T19:58:54Z</dcterms:modified>
</cp:coreProperties>
</file>